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611981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" userDrawn="1">
          <p15:clr>
            <a:srgbClr val="A4A3A4"/>
          </p15:clr>
        </p15:guide>
        <p15:guide id="2" pos="3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1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2790" y="120"/>
      </p:cViewPr>
      <p:guideLst>
        <p:guide orient="horz" pos="453"/>
        <p:guide pos="3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178222"/>
            <a:ext cx="5201841" cy="250642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781306"/>
            <a:ext cx="4589860" cy="1738167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8621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9499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383297"/>
            <a:ext cx="1319585" cy="610108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383297"/>
            <a:ext cx="3882256" cy="610108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38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236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794831"/>
            <a:ext cx="5278339" cy="2994714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4817876"/>
            <a:ext cx="5278339" cy="15748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758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916484"/>
            <a:ext cx="2600921" cy="456789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916484"/>
            <a:ext cx="2600921" cy="456789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065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83299"/>
            <a:ext cx="5278339" cy="139153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764832"/>
            <a:ext cx="2588967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629749"/>
            <a:ext cx="2588967" cy="386796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764832"/>
            <a:ext cx="2601718" cy="86491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629749"/>
            <a:ext cx="2601718" cy="386796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972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033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5022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036570"/>
            <a:ext cx="3098155" cy="511617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1135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79954"/>
            <a:ext cx="1973799" cy="1679840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036570"/>
            <a:ext cx="3098155" cy="511617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159794"/>
            <a:ext cx="1973799" cy="400128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496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383299"/>
            <a:ext cx="5278339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916484"/>
            <a:ext cx="5278339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468BA-8DDE-4E8D-93E5-84149BBA9201}" type="datetimeFigureOut">
              <a:rPr lang="zh-CN" altLang="en-US" smtClean="0"/>
              <a:t>2018/10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6672698"/>
            <a:ext cx="206543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6672698"/>
            <a:ext cx="137695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94DF3-8463-4075-B86F-2A2186AEE3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956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6FA6A119-F137-4308-8ECE-5BE03FF83EDF}"/>
              </a:ext>
            </a:extLst>
          </p:cNvPr>
          <p:cNvGrpSpPr/>
          <p:nvPr/>
        </p:nvGrpSpPr>
        <p:grpSpPr>
          <a:xfrm>
            <a:off x="176177" y="310557"/>
            <a:ext cx="5713760" cy="6528890"/>
            <a:chOff x="176177" y="96493"/>
            <a:chExt cx="5713760" cy="6528890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3688058-7E4D-4730-8901-AEED0C6E03C6}"/>
                </a:ext>
              </a:extLst>
            </p:cNvPr>
            <p:cNvSpPr txBox="1"/>
            <p:nvPr/>
          </p:nvSpPr>
          <p:spPr>
            <a:xfrm>
              <a:off x="187699" y="3282097"/>
              <a:ext cx="359527" cy="371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7A6A565-AB47-4F11-943F-D47FCF1200C9}"/>
                </a:ext>
              </a:extLst>
            </p:cNvPr>
            <p:cNvSpPr txBox="1"/>
            <p:nvPr/>
          </p:nvSpPr>
          <p:spPr>
            <a:xfrm>
              <a:off x="176177" y="96493"/>
              <a:ext cx="371049" cy="371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F64E8A44-5D4F-48BC-9381-ED5D54E2F1F6}"/>
                </a:ext>
              </a:extLst>
            </p:cNvPr>
            <p:cNvGrpSpPr/>
            <p:nvPr/>
          </p:nvGrpSpPr>
          <p:grpSpPr>
            <a:xfrm>
              <a:off x="219256" y="243823"/>
              <a:ext cx="5670681" cy="3193860"/>
              <a:chOff x="219256" y="243823"/>
              <a:chExt cx="5670681" cy="3193860"/>
            </a:xfrm>
          </p:grpSpPr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8DA48E6E-E769-455E-A7FF-DA524B2893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67" t="11798" r="6865" b="14369"/>
              <a:stretch/>
            </p:blipFill>
            <p:spPr>
              <a:xfrm>
                <a:off x="672604" y="2019129"/>
                <a:ext cx="1201896" cy="1080000"/>
              </a:xfrm>
              <a:prstGeom prst="rect">
                <a:avLst/>
              </a:prstGeom>
            </p:spPr>
          </p:pic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259A6ECB-BA22-43A9-A1A4-A4AC4C1CCC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38" t="11896" r="6812" b="14438"/>
              <a:stretch/>
            </p:blipFill>
            <p:spPr>
              <a:xfrm>
                <a:off x="1957771" y="2019129"/>
                <a:ext cx="1205836" cy="1080000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98DD89F7-0127-4B17-85B0-FE7A0042AA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31" t="11973" r="6839" b="14414"/>
              <a:stretch/>
            </p:blipFill>
            <p:spPr>
              <a:xfrm>
                <a:off x="672604" y="709113"/>
                <a:ext cx="1203503" cy="1080000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0E815715-7627-42A6-B143-7D51B2FF7F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208" t="12029" r="6958" b="14472"/>
              <a:stretch/>
            </p:blipFill>
            <p:spPr>
              <a:xfrm>
                <a:off x="1957771" y="709113"/>
                <a:ext cx="1202449" cy="108000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3F0176EE-A343-499F-A575-3BCB7F58EF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21" t="11896" r="6812" b="14438"/>
              <a:stretch/>
            </p:blipFill>
            <p:spPr>
              <a:xfrm>
                <a:off x="3241884" y="709113"/>
                <a:ext cx="1204615" cy="1080000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886BDD93-3C40-4CFB-B86C-08EF4722AA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88" t="11729" r="6812" b="14270"/>
              <a:stretch/>
            </p:blipFill>
            <p:spPr>
              <a:xfrm>
                <a:off x="4528164" y="709113"/>
                <a:ext cx="1196756" cy="1080000"/>
              </a:xfrm>
              <a:prstGeom prst="rect">
                <a:avLst/>
              </a:prstGeom>
            </p:spPr>
          </p:pic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C171CD16-2D0B-465F-BD24-2A21C3AAAF55}"/>
                  </a:ext>
                </a:extLst>
              </p:cNvPr>
              <p:cNvSpPr txBox="1"/>
              <p:nvPr/>
            </p:nvSpPr>
            <p:spPr>
              <a:xfrm>
                <a:off x="1039405" y="509875"/>
                <a:ext cx="4699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4F46E66D-9B8C-4DED-9D67-4ECA240A4C5B}"/>
                  </a:ext>
                </a:extLst>
              </p:cNvPr>
              <p:cNvSpPr txBox="1"/>
              <p:nvPr/>
            </p:nvSpPr>
            <p:spPr>
              <a:xfrm>
                <a:off x="2286190" y="509875"/>
                <a:ext cx="5456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r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2A076A44-19AE-4334-B9B8-81FE8443E798}"/>
                  </a:ext>
                </a:extLst>
              </p:cNvPr>
              <p:cNvSpPr txBox="1"/>
              <p:nvPr/>
            </p:nvSpPr>
            <p:spPr>
              <a:xfrm>
                <a:off x="3571386" y="509875"/>
                <a:ext cx="5456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892256E5-0BE8-492E-AA59-309325E435AD}"/>
                  </a:ext>
                </a:extLst>
              </p:cNvPr>
              <p:cNvSpPr txBox="1"/>
              <p:nvPr/>
            </p:nvSpPr>
            <p:spPr>
              <a:xfrm>
                <a:off x="4853737" y="509875"/>
                <a:ext cx="5456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Q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F0288F45-352E-4AEB-88D1-2648CAD93D7D}"/>
                  </a:ext>
                </a:extLst>
              </p:cNvPr>
              <p:cNvSpPr txBox="1"/>
              <p:nvPr/>
            </p:nvSpPr>
            <p:spPr>
              <a:xfrm>
                <a:off x="814369" y="1789113"/>
                <a:ext cx="9183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r&amp;Tu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8F1529C0-6F1C-4459-85C0-15785DEE0D58}"/>
                  </a:ext>
                </a:extLst>
              </p:cNvPr>
              <p:cNvSpPr txBox="1"/>
              <p:nvPr/>
            </p:nvSpPr>
            <p:spPr>
              <a:xfrm>
                <a:off x="3367496" y="1789113"/>
                <a:ext cx="953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&amp;HCQ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4E4E4F9F-491B-4A99-8D21-3E5518E2E41F}"/>
                  </a:ext>
                </a:extLst>
              </p:cNvPr>
              <p:cNvSpPr txBox="1"/>
              <p:nvPr/>
            </p:nvSpPr>
            <p:spPr>
              <a:xfrm>
                <a:off x="2038532" y="1789113"/>
                <a:ext cx="10443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r&amp;HCQ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ECB9123B-0695-4486-8815-2201232BA9FA}"/>
                  </a:ext>
                </a:extLst>
              </p:cNvPr>
              <p:cNvSpPr txBox="1"/>
              <p:nvPr/>
            </p:nvSpPr>
            <p:spPr>
              <a:xfrm>
                <a:off x="4483012" y="1789113"/>
                <a:ext cx="14069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r&amp;Tu&amp;HCQ</a:t>
                </a:r>
                <a:endParaRPr lang="zh-CN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C1C99ADB-BDEA-40BA-B585-054FAFCE82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21" t="11896" r="6811" b="14438"/>
              <a:stretch/>
            </p:blipFill>
            <p:spPr>
              <a:xfrm>
                <a:off x="3241884" y="2019129"/>
                <a:ext cx="1204615" cy="1080000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0858E079-0C9E-4EC7-BF96-ADD4885F96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88" t="11729" r="6811" b="14437"/>
              <a:stretch/>
            </p:blipFill>
            <p:spPr>
              <a:xfrm>
                <a:off x="4528164" y="2019129"/>
                <a:ext cx="1199458" cy="1080000"/>
              </a:xfrm>
              <a:prstGeom prst="rect">
                <a:avLst/>
              </a:prstGeom>
            </p:spPr>
          </p:pic>
          <p:cxnSp>
            <p:nvCxnSpPr>
              <p:cNvPr id="58" name="直接箭头连接符 57">
                <a:extLst>
                  <a:ext uri="{FF2B5EF4-FFF2-40B4-BE49-F238E27FC236}">
                    <a16:creationId xmlns:a16="http://schemas.microsoft.com/office/drawing/2014/main" id="{718640A5-8898-44B1-B6BA-5FC5EDD032DF}"/>
                  </a:ext>
                </a:extLst>
              </p:cNvPr>
              <p:cNvCxnSpPr/>
              <p:nvPr/>
            </p:nvCxnSpPr>
            <p:spPr>
              <a:xfrm>
                <a:off x="634504" y="3143250"/>
                <a:ext cx="5184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直接箭头连接符 59">
                <a:extLst>
                  <a:ext uri="{FF2B5EF4-FFF2-40B4-BE49-F238E27FC236}">
                    <a16:creationId xmlns:a16="http://schemas.microsoft.com/office/drawing/2014/main" id="{EA0E4330-B2D9-4378-A57D-4873A9F8AD2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-631803" y="1889600"/>
                <a:ext cx="2520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BCD9E96B-14D0-4EED-8229-06CD16EB2C7E}"/>
                  </a:ext>
                </a:extLst>
              </p:cNvPr>
              <p:cNvSpPr txBox="1"/>
              <p:nvPr/>
            </p:nvSpPr>
            <p:spPr>
              <a:xfrm>
                <a:off x="2436127" y="3099129"/>
                <a:ext cx="15807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nexin V-FITC</a:t>
                </a:r>
                <a:endParaRPr lang="zh-CN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2F386B9E-5965-4566-8F6F-C2F3FE0A732D}"/>
                  </a:ext>
                </a:extLst>
              </p:cNvPr>
              <p:cNvSpPr txBox="1"/>
              <p:nvPr/>
            </p:nvSpPr>
            <p:spPr>
              <a:xfrm>
                <a:off x="219256" y="1704934"/>
                <a:ext cx="5062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76D469F1-1CFE-482B-A392-434D746000EA}"/>
                  </a:ext>
                </a:extLst>
              </p:cNvPr>
              <p:cNvSpPr txBox="1"/>
              <p:nvPr/>
            </p:nvSpPr>
            <p:spPr>
              <a:xfrm>
                <a:off x="2666094" y="243823"/>
                <a:ext cx="11208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C7901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1661040E-E3A0-4C48-8CF9-508C804B7933}"/>
                </a:ext>
              </a:extLst>
            </p:cNvPr>
            <p:cNvSpPr txBox="1"/>
            <p:nvPr/>
          </p:nvSpPr>
          <p:spPr>
            <a:xfrm>
              <a:off x="1035064" y="3697575"/>
              <a:ext cx="469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A91BB522-4DEB-4929-8500-01854D92CEB9}"/>
                </a:ext>
              </a:extLst>
            </p:cNvPr>
            <p:cNvSpPr txBox="1"/>
            <p:nvPr/>
          </p:nvSpPr>
          <p:spPr>
            <a:xfrm>
              <a:off x="2290049" y="3697575"/>
              <a:ext cx="545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dr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46C94E14-99D5-47A4-B0EC-10D98DD21081}"/>
                </a:ext>
              </a:extLst>
            </p:cNvPr>
            <p:cNvSpPr txBox="1"/>
            <p:nvPr/>
          </p:nvSpPr>
          <p:spPr>
            <a:xfrm>
              <a:off x="3571133" y="3697575"/>
              <a:ext cx="545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65A122DD-32C3-4BC6-A738-261C0B516EEE}"/>
                </a:ext>
              </a:extLst>
            </p:cNvPr>
            <p:cNvSpPr txBox="1"/>
            <p:nvPr/>
          </p:nvSpPr>
          <p:spPr>
            <a:xfrm>
              <a:off x="4858602" y="3697575"/>
              <a:ext cx="545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Q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643C2938-C868-4C69-BE1F-5CA39B30BBCE}"/>
                </a:ext>
              </a:extLst>
            </p:cNvPr>
            <p:cNvSpPr txBox="1"/>
            <p:nvPr/>
          </p:nvSpPr>
          <p:spPr>
            <a:xfrm>
              <a:off x="811722" y="4976813"/>
              <a:ext cx="9183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dr&amp;Tu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439D7836-E672-480E-A01F-3D51160EC30A}"/>
                </a:ext>
              </a:extLst>
            </p:cNvPr>
            <p:cNvSpPr txBox="1"/>
            <p:nvPr/>
          </p:nvSpPr>
          <p:spPr>
            <a:xfrm>
              <a:off x="3365070" y="4976813"/>
              <a:ext cx="9533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u&amp;HCQ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2648509A-79AD-4111-9F39-B6E16C43606E}"/>
                </a:ext>
              </a:extLst>
            </p:cNvPr>
            <p:cNvSpPr txBox="1"/>
            <p:nvPr/>
          </p:nvSpPr>
          <p:spPr>
            <a:xfrm>
              <a:off x="2035630" y="4976813"/>
              <a:ext cx="10443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dr&amp;HCQ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22E29436-6C8B-4245-8405-CBFB6BE950F4}"/>
                </a:ext>
              </a:extLst>
            </p:cNvPr>
            <p:cNvSpPr txBox="1"/>
            <p:nvPr/>
          </p:nvSpPr>
          <p:spPr>
            <a:xfrm>
              <a:off x="4483012" y="4976813"/>
              <a:ext cx="14069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dr&amp;Tu&amp;HCQ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F8C48376-EA85-4343-B996-CFADAF99A71C}"/>
                </a:ext>
              </a:extLst>
            </p:cNvPr>
            <p:cNvCxnSpPr/>
            <p:nvPr/>
          </p:nvCxnSpPr>
          <p:spPr>
            <a:xfrm>
              <a:off x="634504" y="6330950"/>
              <a:ext cx="5184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直接箭头连接符 83">
              <a:extLst>
                <a:ext uri="{FF2B5EF4-FFF2-40B4-BE49-F238E27FC236}">
                  <a16:creationId xmlns:a16="http://schemas.microsoft.com/office/drawing/2014/main" id="{055A56EE-E22E-4E53-A34E-9B483A95F3B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631803" y="5077300"/>
              <a:ext cx="252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35CB4A6D-84E1-457A-A48C-A0E2BEEB7593}"/>
                </a:ext>
              </a:extLst>
            </p:cNvPr>
            <p:cNvSpPr txBox="1"/>
            <p:nvPr/>
          </p:nvSpPr>
          <p:spPr>
            <a:xfrm>
              <a:off x="2436127" y="6286829"/>
              <a:ext cx="1580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nexin V-FITC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1D84832E-146D-4601-A32D-FE00BA46E5A5}"/>
                </a:ext>
              </a:extLst>
            </p:cNvPr>
            <p:cNvSpPr txBox="1"/>
            <p:nvPr/>
          </p:nvSpPr>
          <p:spPr>
            <a:xfrm>
              <a:off x="219256" y="4892634"/>
              <a:ext cx="5062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9679B540-C357-4F3B-95BE-95E5377AF144}"/>
                </a:ext>
              </a:extLst>
            </p:cNvPr>
            <p:cNvSpPr txBox="1"/>
            <p:nvPr/>
          </p:nvSpPr>
          <p:spPr>
            <a:xfrm>
              <a:off x="2383965" y="3431523"/>
              <a:ext cx="16850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C7901/ADR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9" name="图片 88">
              <a:extLst>
                <a:ext uri="{FF2B5EF4-FFF2-40B4-BE49-F238E27FC236}">
                  <a16:creationId xmlns:a16="http://schemas.microsoft.com/office/drawing/2014/main" id="{B35B8D71-33A4-43E8-BE5B-10A8DC2C54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66" t="11639" r="7066" b="14361"/>
            <a:stretch/>
          </p:blipFill>
          <p:spPr>
            <a:xfrm>
              <a:off x="672604" y="3896813"/>
              <a:ext cx="1194820" cy="1080000"/>
            </a:xfrm>
            <a:prstGeom prst="rect">
              <a:avLst/>
            </a:prstGeom>
          </p:spPr>
        </p:pic>
        <p:pic>
          <p:nvPicPr>
            <p:cNvPr id="91" name="图片 90">
              <a:extLst>
                <a:ext uri="{FF2B5EF4-FFF2-40B4-BE49-F238E27FC236}">
                  <a16:creationId xmlns:a16="http://schemas.microsoft.com/office/drawing/2014/main" id="{B1EBE46D-B87A-469D-8FFE-3E06286891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44" t="12031" r="6671" b="14445"/>
            <a:stretch/>
          </p:blipFill>
          <p:spPr>
            <a:xfrm>
              <a:off x="1957771" y="3896813"/>
              <a:ext cx="1210167" cy="1080000"/>
            </a:xfrm>
            <a:prstGeom prst="rect">
              <a:avLst/>
            </a:prstGeom>
          </p:spPr>
        </p:pic>
        <p:pic>
          <p:nvPicPr>
            <p:cNvPr id="93" name="图片 92">
              <a:extLst>
                <a:ext uri="{FF2B5EF4-FFF2-40B4-BE49-F238E27FC236}">
                  <a16:creationId xmlns:a16="http://schemas.microsoft.com/office/drawing/2014/main" id="{C5121108-558D-4234-8358-6D0987FC82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28" t="11700" r="6639" b="14453"/>
            <a:stretch/>
          </p:blipFill>
          <p:spPr>
            <a:xfrm>
              <a:off x="3241884" y="3896813"/>
              <a:ext cx="1204108" cy="1080000"/>
            </a:xfrm>
            <a:prstGeom prst="rect">
              <a:avLst/>
            </a:prstGeom>
          </p:spPr>
        </p:pic>
        <p:pic>
          <p:nvPicPr>
            <p:cNvPr id="95" name="图片 94">
              <a:extLst>
                <a:ext uri="{FF2B5EF4-FFF2-40B4-BE49-F238E27FC236}">
                  <a16:creationId xmlns:a16="http://schemas.microsoft.com/office/drawing/2014/main" id="{98657975-FFCC-491F-ACF5-0942FAF64C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71" t="11588" r="6462" b="14413"/>
            <a:stretch/>
          </p:blipFill>
          <p:spPr>
            <a:xfrm>
              <a:off x="4528164" y="3896813"/>
              <a:ext cx="1206487" cy="1080000"/>
            </a:xfrm>
            <a:prstGeom prst="rect">
              <a:avLst/>
            </a:prstGeom>
          </p:spPr>
        </p:pic>
        <p:pic>
          <p:nvPicPr>
            <p:cNvPr id="97" name="图片 96">
              <a:extLst>
                <a:ext uri="{FF2B5EF4-FFF2-40B4-BE49-F238E27FC236}">
                  <a16:creationId xmlns:a16="http://schemas.microsoft.com/office/drawing/2014/main" id="{A19F33D8-379A-43DD-8E3F-26D461C374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92" t="11651" r="6992" b="14416"/>
            <a:stretch/>
          </p:blipFill>
          <p:spPr>
            <a:xfrm>
              <a:off x="672604" y="5206829"/>
              <a:ext cx="1196602" cy="1080000"/>
            </a:xfrm>
            <a:prstGeom prst="rect">
              <a:avLst/>
            </a:prstGeom>
          </p:spPr>
        </p:pic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9B01F90B-2431-4388-9522-C0091F745B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1" t="11674" r="6914" b="14326"/>
            <a:stretch/>
          </p:blipFill>
          <p:spPr>
            <a:xfrm>
              <a:off x="1957771" y="5206829"/>
              <a:ext cx="1200032" cy="1080000"/>
            </a:xfrm>
            <a:prstGeom prst="rect">
              <a:avLst/>
            </a:prstGeom>
          </p:spPr>
        </p:pic>
        <p:pic>
          <p:nvPicPr>
            <p:cNvPr id="101" name="图片 100">
              <a:extLst>
                <a:ext uri="{FF2B5EF4-FFF2-40B4-BE49-F238E27FC236}">
                  <a16:creationId xmlns:a16="http://schemas.microsoft.com/office/drawing/2014/main" id="{EA0073F9-CC5F-4F95-B1AE-320E814F36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78" t="11722" r="7016" b="14278"/>
            <a:stretch/>
          </p:blipFill>
          <p:spPr>
            <a:xfrm>
              <a:off x="3241884" y="5206829"/>
              <a:ext cx="1199763" cy="1080000"/>
            </a:xfrm>
            <a:prstGeom prst="rect">
              <a:avLst/>
            </a:prstGeom>
          </p:spPr>
        </p:pic>
        <p:pic>
          <p:nvPicPr>
            <p:cNvPr id="103" name="图片 102">
              <a:extLst>
                <a:ext uri="{FF2B5EF4-FFF2-40B4-BE49-F238E27FC236}">
                  <a16:creationId xmlns:a16="http://schemas.microsoft.com/office/drawing/2014/main" id="{73C52D78-FFF8-48C2-8025-D143F83C31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68" t="11533" r="6832" b="14593"/>
            <a:stretch/>
          </p:blipFill>
          <p:spPr>
            <a:xfrm>
              <a:off x="4528164" y="5206829"/>
              <a:ext cx="1198782" cy="10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36268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7</TotalTime>
  <Words>48</Words>
  <Application>Microsoft Office PowerPoint</Application>
  <PresentationFormat>自定义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龙傲</dc:creator>
  <cp:lastModifiedBy>龙傲</cp:lastModifiedBy>
  <cp:revision>29</cp:revision>
  <dcterms:created xsi:type="dcterms:W3CDTF">2018-05-07T12:40:24Z</dcterms:created>
  <dcterms:modified xsi:type="dcterms:W3CDTF">2018-10-08T08:36:24Z</dcterms:modified>
</cp:coreProperties>
</file>